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9144000" cy="6858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3827" autoAdjust="0"/>
    <p:restoredTop sz="94660"/>
  </p:normalViewPr>
  <p:slideViewPr>
    <p:cSldViewPr snapToGrid="0">
      <p:cViewPr>
        <p:scale>
          <a:sx n="100" d="100"/>
          <a:sy n="100" d="100"/>
        </p:scale>
        <p:origin x="1032" y="-5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E9205-162A-4D48-97ED-246D98D19020}" type="datetimeFigureOut">
              <a:rPr lang="en-GB" smtClean="0"/>
              <a:t>22/10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A538-1D3B-4AD2-9B7C-72D50319F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72041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E9205-162A-4D48-97ED-246D98D19020}" type="datetimeFigureOut">
              <a:rPr lang="en-GB" smtClean="0"/>
              <a:t>22/10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A538-1D3B-4AD2-9B7C-72D50319F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4325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E9205-162A-4D48-97ED-246D98D19020}" type="datetimeFigureOut">
              <a:rPr lang="en-GB" smtClean="0"/>
              <a:t>22/10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A538-1D3B-4AD2-9B7C-72D50319F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40336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E9205-162A-4D48-97ED-246D98D19020}" type="datetimeFigureOut">
              <a:rPr lang="en-GB" smtClean="0"/>
              <a:t>22/10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A538-1D3B-4AD2-9B7C-72D50319F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987828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E9205-162A-4D48-97ED-246D98D19020}" type="datetimeFigureOut">
              <a:rPr lang="en-GB" smtClean="0"/>
              <a:t>22/10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A538-1D3B-4AD2-9B7C-72D50319F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16742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E9205-162A-4D48-97ED-246D98D19020}" type="datetimeFigureOut">
              <a:rPr lang="en-GB" smtClean="0"/>
              <a:t>22/10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A538-1D3B-4AD2-9B7C-72D50319F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26479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E9205-162A-4D48-97ED-246D98D19020}" type="datetimeFigureOut">
              <a:rPr lang="en-GB" smtClean="0"/>
              <a:t>22/10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A538-1D3B-4AD2-9B7C-72D50319F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91739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E9205-162A-4D48-97ED-246D98D19020}" type="datetimeFigureOut">
              <a:rPr lang="en-GB" smtClean="0"/>
              <a:t>22/10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A538-1D3B-4AD2-9B7C-72D50319F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69779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E9205-162A-4D48-97ED-246D98D19020}" type="datetimeFigureOut">
              <a:rPr lang="en-GB" smtClean="0"/>
              <a:t>22/10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A538-1D3B-4AD2-9B7C-72D50319F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02019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E9205-162A-4D48-97ED-246D98D19020}" type="datetimeFigureOut">
              <a:rPr lang="en-GB" smtClean="0"/>
              <a:t>22/10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A538-1D3B-4AD2-9B7C-72D50319F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26234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E9205-162A-4D48-97ED-246D98D19020}" type="datetimeFigureOut">
              <a:rPr lang="en-GB" smtClean="0"/>
              <a:t>22/10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A538-1D3B-4AD2-9B7C-72D50319F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98106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9E9205-162A-4D48-97ED-246D98D19020}" type="datetimeFigureOut">
              <a:rPr lang="en-GB" smtClean="0"/>
              <a:t>22/10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F8A538-1D3B-4AD2-9B7C-72D50319F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01180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044" y="7223"/>
            <a:ext cx="21961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Picture 11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584806"/>
            <a:ext cx="3600000" cy="2880000"/>
          </a:xfrm>
          <a:prstGeom prst="rect">
            <a:avLst/>
          </a:prstGeom>
        </p:spPr>
      </p:pic>
      <p:pic>
        <p:nvPicPr>
          <p:cNvPr id="9" name="Picture 8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13063" y="3424240"/>
            <a:ext cx="3600000" cy="22680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0" y="5636035"/>
            <a:ext cx="91440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etection of SA-β-galactosidase staining in low proliferative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PSC 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b-populations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presentativ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A-β-galactosidase microscopy images and % positively stained cell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alculation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or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ow proliferative sub-populations, (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2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2-10PDs) and 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</a:t>
            </a:r>
            <a:r>
              <a:rPr lang="en-US" sz="12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C3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2-10PDs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.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cale bar 100μm, ×10 magnification.  N=3, values represent the mean ± SEM. 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p&lt;0.05, ***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&lt;0.001 versus untreated DPSC controls.</a:t>
            </a:r>
            <a:endParaRPr lang="en-US" sz="1200" dirty="0" smtClean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6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5544000" y="584806"/>
            <a:ext cx="3600000" cy="2880000"/>
          </a:xfrm>
          <a:prstGeom prst="rect">
            <a:avLst/>
          </a:prstGeom>
        </p:spPr>
      </p:pic>
      <p:pic>
        <p:nvPicPr>
          <p:cNvPr id="8" name="Picture 7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5549747" y="3424240"/>
            <a:ext cx="3600000" cy="226800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C3983FF8-E430-4E2B-AFE7-A3B7F3008A84}"/>
              </a:ext>
            </a:extLst>
          </p:cNvPr>
          <p:cNvSpPr txBox="1"/>
          <p:nvPr/>
        </p:nvSpPr>
        <p:spPr>
          <a:xfrm>
            <a:off x="9525" y="306693"/>
            <a:ext cx="360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3983FF8-E430-4E2B-AFE7-A3B7F3008A84}"/>
              </a:ext>
            </a:extLst>
          </p:cNvPr>
          <p:cNvSpPr txBox="1"/>
          <p:nvPr/>
        </p:nvSpPr>
        <p:spPr>
          <a:xfrm>
            <a:off x="5491585" y="289274"/>
            <a:ext cx="360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81596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559</TotalTime>
  <Words>73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Cardiff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 for Paper</dc:title>
  <dc:creator>insrv</dc:creator>
  <cp:lastModifiedBy>Ryan Moseley</cp:lastModifiedBy>
  <cp:revision>300</cp:revision>
  <cp:lastPrinted>2018-10-18T13:09:14Z</cp:lastPrinted>
  <dcterms:created xsi:type="dcterms:W3CDTF">2017-05-24T09:17:58Z</dcterms:created>
  <dcterms:modified xsi:type="dcterms:W3CDTF">2020-10-22T11:18:20Z</dcterms:modified>
</cp:coreProperties>
</file>